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69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5B4C9-9F13-45F9-9CDC-F02BFACD0477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A697D-A554-4C2D-980C-CB1DEE951D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54004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5B4C9-9F13-45F9-9CDC-F02BFACD0477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A697D-A554-4C2D-980C-CB1DEE951D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9000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5B4C9-9F13-45F9-9CDC-F02BFACD0477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A697D-A554-4C2D-980C-CB1DEE951D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97457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5B4C9-9F13-45F9-9CDC-F02BFACD0477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A697D-A554-4C2D-980C-CB1DEE951D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8660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5B4C9-9F13-45F9-9CDC-F02BFACD0477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A697D-A554-4C2D-980C-CB1DEE951D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595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5B4C9-9F13-45F9-9CDC-F02BFACD0477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A697D-A554-4C2D-980C-CB1DEE951D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8599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5B4C9-9F13-45F9-9CDC-F02BFACD0477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A697D-A554-4C2D-980C-CB1DEE951D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7044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5B4C9-9F13-45F9-9CDC-F02BFACD0477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A697D-A554-4C2D-980C-CB1DEE951D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3196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5B4C9-9F13-45F9-9CDC-F02BFACD0477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A697D-A554-4C2D-980C-CB1DEE951D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28660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5B4C9-9F13-45F9-9CDC-F02BFACD0477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A697D-A554-4C2D-980C-CB1DEE951D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6943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5B4C9-9F13-45F9-9CDC-F02BFACD0477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A697D-A554-4C2D-980C-CB1DEE951D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5148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B5B4C9-9F13-45F9-9CDC-F02BFACD0477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1A697D-A554-4C2D-980C-CB1DEE951D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2660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872675" y="5115069"/>
            <a:ext cx="109095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. S1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Phylogenetic tree analysis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ultiple sequence analysis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of FtbZIP12. (a) Phylogenetic tree analysis of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ZIP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subfamily  in different species. (b) Protein align of FtbZIP12 and FlbZIP12.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1487" y="0"/>
            <a:ext cx="6300227" cy="4839305"/>
          </a:xfrm>
          <a:prstGeom prst="rect">
            <a:avLst/>
          </a:prstGeom>
        </p:spPr>
      </p:pic>
      <p:graphicFrame>
        <p:nvGraphicFramePr>
          <p:cNvPr id="7" name="对象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1215658"/>
              </p:ext>
            </p:extLst>
          </p:nvPr>
        </p:nvGraphicFramePr>
        <p:xfrm>
          <a:off x="6412140" y="341993"/>
          <a:ext cx="5263656" cy="5724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工作表" r:id="rId4" imgW="3358288" imgH="364715" progId="Excel.Sheet.12">
                  <p:embed/>
                </p:oleObj>
              </mc:Choice>
              <mc:Fallback>
                <p:oleObj name="工作表" r:id="rId4" imgW="3358288" imgH="364715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412140" y="341993"/>
                        <a:ext cx="5263656" cy="5724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文本框 7"/>
          <p:cNvSpPr txBox="1"/>
          <p:nvPr/>
        </p:nvSpPr>
        <p:spPr>
          <a:xfrm>
            <a:off x="297543" y="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099234" y="1944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7707084" y="142556"/>
            <a:ext cx="4572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4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9615713" y="142556"/>
            <a:ext cx="4572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4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1982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40</Words>
  <Application>Microsoft Office PowerPoint</Application>
  <PresentationFormat>宽屏</PresentationFormat>
  <Paragraphs>5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Microsoft Excel 工作表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4</cp:revision>
  <dcterms:created xsi:type="dcterms:W3CDTF">2023-07-17T00:30:50Z</dcterms:created>
  <dcterms:modified xsi:type="dcterms:W3CDTF">2023-07-17T00:49:44Z</dcterms:modified>
</cp:coreProperties>
</file>